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A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8" d="100"/>
          <a:sy n="58" d="100"/>
        </p:scale>
        <p:origin x="96" y="6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C4694-F3B8-4F56-B571-C2A0E597D5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604446-C423-49F9-BEAE-80FCC74006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C9CCC-E0B7-48D2-8356-1B6DC924E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A832E9-E92F-4CC7-9BB7-8D5EC3F8B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C9E69-09AA-4E7A-8F5C-557A4F249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003929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C42571-A942-4FFA-A0FF-0BCF20B82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953C5D-C667-466D-B328-223938AC9F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F7C0D7-3362-4CEB-8B05-2C46E2F1F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F60B21-3A42-45E2-975D-5F0BC6163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489614-7423-4134-86F5-564A5BC8B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8506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FFDD9C-B7D2-47ED-9A16-84DF6D901A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697B0B-786E-4927-AAA3-04EBA4CF1A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31F179-71CA-4407-ABC3-7B780C5D7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092891-1339-45DB-8C48-4AFF84012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92A7D7-A094-4E34-8EFC-C6E8C5BAA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746892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AC471-5A97-4CDA-B207-08736817A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072DE4-BEA4-487E-B70D-8B66D8B4DB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24973C-75D8-438C-8CCF-3453BFEAE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7F6B73-5B3C-43CA-93C8-ACA90CB0A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1C89C2-F505-4C69-8460-AC462AA26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004402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DA57F-02E1-407D-8DD6-CA9706F956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3D3A25-8B08-4A9C-AB62-97B5674DFF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9BAD77-9585-49C3-B152-F1A919FD5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C052CD-F96B-4D67-88D8-4A526EA17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4C52A-5C8B-44C7-BDC6-8C7F7934C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869243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DDF60-C7CC-46C3-A16C-86A977BD7B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FEA045-AAD9-489D-9CDC-DF02A2D924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E69BF1-27E1-4C34-B7A7-65BDA51E8A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A747B3-9AB8-4653-B335-7F8CFB8E5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72345-1FA8-4FB3-A376-E252096E3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F1C169-9640-46E2-BA18-940F66C4D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503203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A5D97-5FDF-4A96-99E4-A4DAC4FAB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D3B05D-EB04-4983-816D-D1A4EC669D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A04065-01BD-4659-A9ED-1448F0ABFA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5A7C5F-747B-44A0-B8C8-D3C792DE7D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02AD46-70F2-493E-BB06-9DA28A7E37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789F23-96CF-44DF-ADB1-41AE71BFB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C115AB-3311-4B1E-910D-B10ED167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E4E0C13-7220-4208-9008-87745B5C5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195034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8C96F-E4EC-43FF-801F-C5F6A69206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1807DD-FB13-4DCC-98FB-F87248771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D7396E-9CCB-462E-B92E-8FBCD5EB4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3F3E7C-8CCA-404A-932E-D7D7F2358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750317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CD9D5C-B786-4E64-AB3C-09266F436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3FC182-C9A1-4F00-875C-16999308C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8ACBF8-36A6-4CC4-877A-CB63D30EA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869932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A9E05-A161-4D50-B9A1-3A8AB55A99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B05288-61DB-43D7-B4B7-087C202899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410D17-38D2-4020-97C4-8E9362E5DB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675F4E-42F2-4640-8F23-A077E06FD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E4B0C3-8167-452C-AD06-2B684D85F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FA9194-5923-4A93-89DB-47C14E37C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4077007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9BAF8E-CD1C-4778-A380-B1B88DFD8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EB3468-7CFC-42BB-8D70-707F9AC953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51CC88-8A32-45DC-A604-BB57E20A78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F80B25-046C-418B-BC7E-122A0B4BA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58E2EB-3C71-49C8-9BCE-F613B0321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70FF8-7D44-4884-8F89-432C6F98E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474699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ED00D8-69BF-4BEF-B1FF-DFAE02A64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AE368C-AEFD-405A-9C1E-7C64F49A8B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22C1D8-3633-49BB-BCC3-8838B2A804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0AF2F-F511-4488-81D9-28A6CC2BE1AC}" type="datetimeFigureOut">
              <a:rPr lang="en-AT" smtClean="0"/>
              <a:t>03/30/2023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E89B03-E9DD-4F2E-BEB7-2DC6F42951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F1274-A890-4BC1-AD65-31ABA2B818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31FB9-3668-4310-8084-831DF279279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607529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A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14747"/>
          <a:stretch/>
        </p:blipFill>
        <p:spPr>
          <a:xfrm>
            <a:off x="572730" y="519063"/>
            <a:ext cx="6652092" cy="407743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13938"/>
          <a:stretch/>
        </p:blipFill>
        <p:spPr>
          <a:xfrm>
            <a:off x="7661749" y="140331"/>
            <a:ext cx="3570993" cy="259470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b="14012"/>
          <a:stretch/>
        </p:blipFill>
        <p:spPr>
          <a:xfrm>
            <a:off x="7458820" y="2910430"/>
            <a:ext cx="3773922" cy="275558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35802" y="140330"/>
            <a:ext cx="11896253" cy="65501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E8691C-F5AD-4B83-88B4-0B96AB52D291}"/>
              </a:ext>
            </a:extLst>
          </p:cNvPr>
          <p:cNvSpPr txBox="1"/>
          <p:nvPr/>
        </p:nvSpPr>
        <p:spPr>
          <a:xfrm>
            <a:off x="414935" y="6019858"/>
            <a:ext cx="116232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gure </a:t>
            </a:r>
            <a:r>
              <a:rPr lang="en-GB" sz="1600" b="1" dirty="0" smtClean="0"/>
              <a:t>S1: </a:t>
            </a:r>
            <a:r>
              <a:rPr lang="en-GB" sz="1600" dirty="0"/>
              <a:t>Functional distribution of the proteome identified in different cell layers </a:t>
            </a:r>
            <a:r>
              <a:rPr lang="en-GB" sz="1600" dirty="0" smtClean="0"/>
              <a:t>of </a:t>
            </a:r>
            <a:r>
              <a:rPr lang="en-GB" sz="1600" dirty="0"/>
              <a:t>the developing wheat endosperm (</a:t>
            </a:r>
            <a:r>
              <a:rPr lang="en-GB" sz="1600" dirty="0" smtClean="0"/>
              <a:t>15 and </a:t>
            </a:r>
            <a:r>
              <a:rPr lang="en-GB" sz="1600" dirty="0"/>
              <a:t>26 DAA). </a:t>
            </a:r>
            <a:r>
              <a:rPr lang="en-GB" sz="1600" b="1" dirty="0"/>
              <a:t>Abbreviations:</a:t>
            </a:r>
            <a:r>
              <a:rPr lang="en-GB" sz="1600" dirty="0"/>
              <a:t> DAA: Days after anthesis; AL: Aleurone; SA: </a:t>
            </a:r>
            <a:r>
              <a:rPr lang="en-GB" sz="1600" dirty="0" smtClean="0"/>
              <a:t>Sub-aleurone</a:t>
            </a:r>
            <a:r>
              <a:rPr lang="en-GB" sz="1600" dirty="0"/>
              <a:t>; SE: Starchy </a:t>
            </a:r>
            <a:r>
              <a:rPr lang="en-GB" sz="1600" dirty="0" smtClean="0"/>
              <a:t>Endosperm</a:t>
            </a:r>
            <a:r>
              <a:rPr lang="en-GB" sz="1600" dirty="0"/>
              <a:t>; ETCs: Endosperm </a:t>
            </a:r>
            <a:r>
              <a:rPr lang="en-GB" sz="1600" dirty="0" smtClean="0"/>
              <a:t>Transfer Cells</a:t>
            </a:r>
            <a:r>
              <a:rPr lang="en-GB" sz="1600" dirty="0"/>
              <a:t>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95631" y="4529344"/>
            <a:ext cx="489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AL</a:t>
            </a:r>
            <a:endParaRPr lang="de-AT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296524" y="4522188"/>
            <a:ext cx="489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SA</a:t>
            </a:r>
            <a:endParaRPr lang="de-AT" sz="1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713674" y="4529344"/>
            <a:ext cx="489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SE</a:t>
            </a:r>
            <a:endParaRPr lang="de-AT" sz="1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114567" y="4521649"/>
            <a:ext cx="4898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SE</a:t>
            </a:r>
            <a:endParaRPr lang="de-AT" sz="1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518370" y="4521684"/>
            <a:ext cx="489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SA</a:t>
            </a:r>
            <a:endParaRPr lang="de-AT" sz="1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905735" y="4521649"/>
            <a:ext cx="4898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AL</a:t>
            </a:r>
            <a:endParaRPr lang="de-AT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283354" y="4529813"/>
            <a:ext cx="6505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ETCs</a:t>
            </a:r>
            <a:endParaRPr lang="de-AT" sz="1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713342" y="4529813"/>
            <a:ext cx="6505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ETCs</a:t>
            </a:r>
            <a:endParaRPr lang="de-AT" sz="10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8366185" y="2659279"/>
            <a:ext cx="4898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AL</a:t>
            </a:r>
            <a:endParaRPr lang="de-AT" sz="10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8798106" y="2654866"/>
            <a:ext cx="489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SA</a:t>
            </a:r>
            <a:endParaRPr lang="de-AT" sz="10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259837" y="2656513"/>
            <a:ext cx="4898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SE</a:t>
            </a:r>
            <a:endParaRPr lang="de-AT" sz="10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9637456" y="2656513"/>
            <a:ext cx="6505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 ETCs</a:t>
            </a:r>
            <a:endParaRPr lang="de-AT" sz="10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8249163" y="5590257"/>
            <a:ext cx="4898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AL</a:t>
            </a:r>
            <a:endParaRPr lang="de-AT" sz="1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8698893" y="5585843"/>
            <a:ext cx="489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SA</a:t>
            </a:r>
            <a:endParaRPr lang="de-AT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9170941" y="5587491"/>
            <a:ext cx="4898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SE</a:t>
            </a:r>
            <a:endParaRPr lang="de-AT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9579225" y="5587491"/>
            <a:ext cx="6505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 ETCs</a:t>
            </a:r>
            <a:endParaRPr lang="de-AT" sz="1000" b="1" dirty="0"/>
          </a:p>
        </p:txBody>
      </p:sp>
    </p:spTree>
    <p:extLst>
      <p:ext uri="{BB962C8B-B14F-4D97-AF65-F5344CB8AC3E}">
        <p14:creationId xmlns:p14="http://schemas.microsoft.com/office/powerpoint/2010/main" val="18052140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2394" y="409575"/>
            <a:ext cx="5733959" cy="168091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49334" y="409575"/>
            <a:ext cx="2780577" cy="153167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12394" y="2090489"/>
            <a:ext cx="5796798" cy="157094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49334" y="2047288"/>
            <a:ext cx="2929818" cy="165735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43813" y="3771403"/>
            <a:ext cx="5765379" cy="163378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899718" y="311604"/>
            <a:ext cx="822552" cy="379639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135802" y="140330"/>
            <a:ext cx="11896253" cy="65501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3" name="Rectangle 12"/>
          <p:cNvSpPr/>
          <p:nvPr/>
        </p:nvSpPr>
        <p:spPr>
          <a:xfrm>
            <a:off x="519064" y="5611596"/>
            <a:ext cx="1151299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AT" sz="1400" dirty="0"/>
              <a:t>Figure </a:t>
            </a:r>
            <a:r>
              <a:rPr lang="de-AT" sz="1400" dirty="0" smtClean="0"/>
              <a:t>S2. Bar </a:t>
            </a:r>
            <a:r>
              <a:rPr lang="de-AT" sz="1400" dirty="0" err="1"/>
              <a:t>graph</a:t>
            </a:r>
            <a:r>
              <a:rPr lang="de-AT" sz="1400" dirty="0"/>
              <a:t> </a:t>
            </a:r>
            <a:r>
              <a:rPr lang="de-AT" sz="1400" dirty="0" err="1"/>
              <a:t>represents</a:t>
            </a:r>
            <a:r>
              <a:rPr lang="de-AT" sz="1400" dirty="0"/>
              <a:t> </a:t>
            </a:r>
            <a:r>
              <a:rPr lang="de-AT" sz="1400" dirty="0" err="1"/>
              <a:t>the</a:t>
            </a:r>
            <a:r>
              <a:rPr lang="de-AT" sz="1400" dirty="0"/>
              <a:t> </a:t>
            </a:r>
            <a:r>
              <a:rPr lang="de-AT" sz="1400" dirty="0" err="1"/>
              <a:t>accumulation</a:t>
            </a:r>
            <a:r>
              <a:rPr lang="de-AT" sz="1400" dirty="0"/>
              <a:t> </a:t>
            </a:r>
            <a:r>
              <a:rPr lang="de-AT" sz="1400" dirty="0" err="1"/>
              <a:t>pattern</a:t>
            </a:r>
            <a:r>
              <a:rPr lang="de-AT" sz="1400" dirty="0"/>
              <a:t> of </a:t>
            </a:r>
            <a:r>
              <a:rPr lang="de-AT" sz="1400" dirty="0" err="1"/>
              <a:t>the</a:t>
            </a:r>
            <a:r>
              <a:rPr lang="de-AT" sz="1400" dirty="0"/>
              <a:t> </a:t>
            </a:r>
            <a:r>
              <a:rPr lang="de-AT" sz="1400" dirty="0" err="1"/>
              <a:t>selected</a:t>
            </a:r>
            <a:r>
              <a:rPr lang="de-AT" sz="1400" dirty="0"/>
              <a:t> </a:t>
            </a:r>
            <a:r>
              <a:rPr lang="de-AT" sz="1400" dirty="0" err="1"/>
              <a:t>proteins</a:t>
            </a:r>
            <a:r>
              <a:rPr lang="de-AT" sz="1400" dirty="0"/>
              <a:t>. </a:t>
            </a:r>
            <a:r>
              <a:rPr lang="de-AT" sz="1400" dirty="0" err="1"/>
              <a:t>Mean</a:t>
            </a:r>
            <a:r>
              <a:rPr lang="de-AT" sz="1400" dirty="0"/>
              <a:t> of </a:t>
            </a:r>
            <a:r>
              <a:rPr lang="de-AT" sz="1400" dirty="0" err="1"/>
              <a:t>the</a:t>
            </a:r>
            <a:r>
              <a:rPr lang="de-AT" sz="1400" dirty="0"/>
              <a:t> </a:t>
            </a:r>
            <a:r>
              <a:rPr lang="de-AT" sz="1400" dirty="0" err="1"/>
              <a:t>abundance</a:t>
            </a:r>
            <a:r>
              <a:rPr lang="de-AT" sz="1400" dirty="0"/>
              <a:t> </a:t>
            </a:r>
            <a:r>
              <a:rPr lang="de-AT" sz="1400" dirty="0" err="1"/>
              <a:t>levels</a:t>
            </a:r>
            <a:r>
              <a:rPr lang="de-AT" sz="1400" dirty="0"/>
              <a:t> from </a:t>
            </a:r>
            <a:r>
              <a:rPr lang="de-AT" sz="1400" dirty="0" err="1"/>
              <a:t>four</a:t>
            </a:r>
            <a:r>
              <a:rPr lang="de-AT" sz="1400" dirty="0"/>
              <a:t> different </a:t>
            </a:r>
            <a:r>
              <a:rPr lang="de-AT" sz="1400" dirty="0" err="1"/>
              <a:t>cell</a:t>
            </a:r>
            <a:r>
              <a:rPr lang="de-AT" sz="1400" dirty="0"/>
              <a:t> </a:t>
            </a:r>
            <a:r>
              <a:rPr lang="de-AT" sz="1400" dirty="0" err="1"/>
              <a:t>layers</a:t>
            </a:r>
            <a:r>
              <a:rPr lang="de-AT" sz="1400" dirty="0"/>
              <a:t> in </a:t>
            </a:r>
            <a:r>
              <a:rPr lang="de-AT" sz="1400" dirty="0" err="1"/>
              <a:t>the</a:t>
            </a:r>
            <a:r>
              <a:rPr lang="de-AT" sz="1400" dirty="0"/>
              <a:t> grain </a:t>
            </a:r>
            <a:r>
              <a:rPr lang="de-AT" sz="1400" dirty="0" err="1"/>
              <a:t>developmental</a:t>
            </a:r>
            <a:r>
              <a:rPr lang="de-AT" sz="1400" dirty="0"/>
              <a:t> </a:t>
            </a:r>
            <a:r>
              <a:rPr lang="de-AT" sz="1400" dirty="0" err="1"/>
              <a:t>stages</a:t>
            </a:r>
            <a:r>
              <a:rPr lang="de-AT" sz="1400" dirty="0"/>
              <a:t> (15 and 26 DAA). Data </a:t>
            </a:r>
            <a:r>
              <a:rPr lang="de-AT" sz="1400" dirty="0" err="1"/>
              <a:t>are</a:t>
            </a:r>
            <a:r>
              <a:rPr lang="de-AT" sz="1400" dirty="0"/>
              <a:t> </a:t>
            </a:r>
            <a:r>
              <a:rPr lang="de-AT" sz="1400" dirty="0" err="1"/>
              <a:t>represented</a:t>
            </a:r>
            <a:r>
              <a:rPr lang="de-AT" sz="1400" dirty="0"/>
              <a:t> </a:t>
            </a:r>
            <a:r>
              <a:rPr lang="de-AT" sz="1400" dirty="0" err="1"/>
              <a:t>as</a:t>
            </a:r>
            <a:r>
              <a:rPr lang="de-AT" sz="1400" dirty="0"/>
              <a:t> </a:t>
            </a:r>
            <a:r>
              <a:rPr lang="de-AT" sz="1400" dirty="0" err="1"/>
              <a:t>mean</a:t>
            </a:r>
            <a:r>
              <a:rPr lang="de-AT" sz="1400" dirty="0"/>
              <a:t> ± </a:t>
            </a:r>
            <a:r>
              <a:rPr lang="de-AT" sz="1400" dirty="0" err="1"/>
              <a:t>standard</a:t>
            </a:r>
            <a:r>
              <a:rPr lang="de-AT" sz="1400" dirty="0"/>
              <a:t> </a:t>
            </a:r>
            <a:r>
              <a:rPr lang="de-AT" sz="1400" dirty="0" err="1"/>
              <a:t>deviation</a:t>
            </a:r>
            <a:r>
              <a:rPr lang="de-AT" sz="1400" dirty="0"/>
              <a:t> from </a:t>
            </a:r>
            <a:r>
              <a:rPr lang="de-AT" sz="1400" dirty="0" err="1"/>
              <a:t>three</a:t>
            </a:r>
            <a:r>
              <a:rPr lang="de-AT" sz="1400" dirty="0"/>
              <a:t> </a:t>
            </a:r>
            <a:r>
              <a:rPr lang="de-AT" sz="1400" dirty="0" err="1"/>
              <a:t>biological</a:t>
            </a:r>
            <a:r>
              <a:rPr lang="de-AT" sz="1400" dirty="0"/>
              <a:t> </a:t>
            </a:r>
            <a:r>
              <a:rPr lang="de-AT" sz="1400" dirty="0" err="1"/>
              <a:t>replicates</a:t>
            </a:r>
            <a:r>
              <a:rPr lang="de-AT" sz="1400" dirty="0"/>
              <a:t> </a:t>
            </a:r>
            <a:r>
              <a:rPr lang="de-AT" sz="1400" dirty="0" err="1"/>
              <a:t>for</a:t>
            </a:r>
            <a:r>
              <a:rPr lang="de-AT" sz="1400" dirty="0"/>
              <a:t> </a:t>
            </a:r>
            <a:r>
              <a:rPr lang="de-AT" sz="1400" dirty="0" err="1"/>
              <a:t>each</a:t>
            </a:r>
            <a:r>
              <a:rPr lang="de-AT" sz="1400" dirty="0"/>
              <a:t> </a:t>
            </a:r>
            <a:r>
              <a:rPr lang="de-AT" sz="1400" dirty="0" err="1"/>
              <a:t>cell</a:t>
            </a:r>
            <a:r>
              <a:rPr lang="de-AT" sz="1400" dirty="0"/>
              <a:t> </a:t>
            </a:r>
            <a:r>
              <a:rPr lang="de-AT" sz="1400" dirty="0" err="1"/>
              <a:t>layer</a:t>
            </a:r>
            <a:r>
              <a:rPr lang="de-AT" sz="1400" dirty="0"/>
              <a:t> and </a:t>
            </a:r>
            <a:r>
              <a:rPr lang="de-AT" sz="1400" dirty="0" err="1"/>
              <a:t>developmental</a:t>
            </a:r>
            <a:r>
              <a:rPr lang="de-AT" sz="1400" dirty="0"/>
              <a:t> </a:t>
            </a:r>
            <a:r>
              <a:rPr lang="de-AT" sz="1400" dirty="0" err="1"/>
              <a:t>stages</a:t>
            </a:r>
            <a:r>
              <a:rPr lang="de-AT" sz="1400" dirty="0"/>
              <a:t>. (*p-value &lt;0.05) </a:t>
            </a:r>
            <a:r>
              <a:rPr lang="de-AT" sz="1400" dirty="0" err="1"/>
              <a:t>indicates</a:t>
            </a:r>
            <a:r>
              <a:rPr lang="de-AT" sz="1400" dirty="0"/>
              <a:t> </a:t>
            </a:r>
            <a:r>
              <a:rPr lang="de-AT" sz="1400" dirty="0" err="1"/>
              <a:t>significant</a:t>
            </a:r>
            <a:r>
              <a:rPr lang="de-AT" sz="1400" dirty="0"/>
              <a:t> </a:t>
            </a:r>
            <a:r>
              <a:rPr lang="de-AT" sz="1400" dirty="0" err="1"/>
              <a:t>up</a:t>
            </a:r>
            <a:r>
              <a:rPr lang="de-AT" sz="1400" dirty="0"/>
              <a:t>-regulation of </a:t>
            </a:r>
            <a:r>
              <a:rPr lang="de-AT" sz="1400" dirty="0" err="1"/>
              <a:t>protein</a:t>
            </a:r>
            <a:r>
              <a:rPr lang="de-AT" sz="1400" dirty="0"/>
              <a:t> </a:t>
            </a:r>
            <a:r>
              <a:rPr lang="de-AT" sz="1400" dirty="0" err="1"/>
              <a:t>candidates</a:t>
            </a:r>
            <a:r>
              <a:rPr lang="de-AT" sz="1400" dirty="0"/>
              <a:t>. Abbreviation: DAA: Days after anthesis; aleurone (AL); </a:t>
            </a:r>
            <a:r>
              <a:rPr lang="de-AT" sz="1400" dirty="0" err="1"/>
              <a:t>sub</a:t>
            </a:r>
            <a:r>
              <a:rPr lang="de-AT" sz="1400" dirty="0"/>
              <a:t> </a:t>
            </a:r>
            <a:r>
              <a:rPr lang="de-AT" sz="1400" dirty="0" smtClean="0"/>
              <a:t>-aleurone </a:t>
            </a:r>
            <a:r>
              <a:rPr lang="de-AT" sz="1400" dirty="0"/>
              <a:t>(SA); </a:t>
            </a:r>
            <a:r>
              <a:rPr lang="de-AT" sz="1400" dirty="0" err="1"/>
              <a:t>starchy</a:t>
            </a:r>
            <a:r>
              <a:rPr lang="de-AT" sz="1400" dirty="0"/>
              <a:t> </a:t>
            </a:r>
            <a:r>
              <a:rPr lang="de-AT" sz="1400" dirty="0" err="1"/>
              <a:t>endosperm</a:t>
            </a:r>
            <a:r>
              <a:rPr lang="de-AT" sz="1400" dirty="0"/>
              <a:t> (SE);  </a:t>
            </a:r>
            <a:r>
              <a:rPr lang="de-AT" sz="1400" dirty="0" err="1"/>
              <a:t>endosperm</a:t>
            </a:r>
            <a:r>
              <a:rPr lang="de-AT" sz="1400" dirty="0"/>
              <a:t> </a:t>
            </a:r>
            <a:r>
              <a:rPr lang="de-AT" sz="1400" dirty="0" err="1"/>
              <a:t>transfer</a:t>
            </a:r>
            <a:r>
              <a:rPr lang="de-AT" sz="1400" dirty="0"/>
              <a:t> </a:t>
            </a:r>
            <a:r>
              <a:rPr lang="de-AT" sz="1400" dirty="0" err="1"/>
              <a:t>cells</a:t>
            </a:r>
            <a:r>
              <a:rPr lang="de-AT" sz="1400" dirty="0"/>
              <a:t> (ETCs). </a:t>
            </a:r>
          </a:p>
        </p:txBody>
      </p:sp>
    </p:spTree>
    <p:extLst>
      <p:ext uri="{BB962C8B-B14F-4D97-AF65-F5344CB8AC3E}">
        <p14:creationId xmlns:p14="http://schemas.microsoft.com/office/powerpoint/2010/main" val="1748556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</Words>
  <Application>Microsoft Office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lak</dc:creator>
  <cp:lastModifiedBy>Palak</cp:lastModifiedBy>
  <cp:revision>11</cp:revision>
  <dcterms:created xsi:type="dcterms:W3CDTF">2022-08-28T18:58:25Z</dcterms:created>
  <dcterms:modified xsi:type="dcterms:W3CDTF">2023-03-29T21:19:06Z</dcterms:modified>
</cp:coreProperties>
</file>